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9456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08F23C3-9571-F771-0300-2E6F7C6D73CE}" name="Anne Finucane" initials="AF" userId="S::afinucan@ed.ac.uk::9591562c-bdb0-488b-9538-a0eff5953df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7F01"/>
    <a:srgbClr val="71035F"/>
    <a:srgbClr val="FFFF66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E96B36-354A-4786-B223-338178639F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FC9708-2EE5-41C2-9B55-CB45B655AC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55FAE8-6D4E-4117-AE98-4F5D9100D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00F9AC-51C2-4FF0-974C-4E5F7D84E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400DFB-F3F0-465C-986D-6A18C90C6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978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799ACD-2C05-4D7E-BADC-6DDC73C00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6D93BB-2AE7-49A2-A53D-2A2FAD524C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9A619C-364A-4170-9089-617271BCA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C7F96-3BF3-4F5E-A4B7-79780A4A1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E4299A-3F95-43AA-AEFD-2BAA7B311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133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FE9FE46-94E0-44D1-8D95-28D34EA7E0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944F41-D48A-4AD1-BABF-FA28E3C937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ACD04-DD42-407F-A9D9-AA27CC759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D0622-102A-44D8-ABC7-F980E8D8F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B837C-2550-4E9C-A767-4CB515224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272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2292F-29CC-43AC-8E6D-DA2E62A8C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5B0852-01C4-4537-8596-ED9898A6A4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990B8E-0889-4DE9-9AA0-C39454A60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CC1B58-5668-4332-8B99-F329AF38F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8C01B7-4E60-412D-9AE5-4A3775E55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991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782D4-9905-471E-9178-B5A4C0A14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85FD61-5172-4655-9732-8D6B2E6D22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48421-39B7-4493-BB6B-5FE99A200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5B9F7-00FF-4901-AE82-D3DD4CDEB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7678F6-21B3-4508-88F5-AE09C8AF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5693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105D4-026A-48C6-AF3E-8F653CF8E2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A14354-548E-403F-B31E-3FBE502734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5F63D8-4B4D-4B6E-AA7F-6AD80FFA4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07AE5F-2964-4F8A-AAF3-351C07639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BF63B7-9602-4985-8157-369352021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7C93AE-DD97-4A08-974A-2BA7469C0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0219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EE75E0-DA2E-4C2E-A7AF-FC9838510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C3DFA1-0F21-482F-B60D-391A8C5FD1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AF3945-EFB7-40BE-998D-69B4DF4C4F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F1A160-7CDE-4CE8-99BA-38F3CEA989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B90D92-E5F5-4A94-9EFB-F501BE8F5C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F5C5B9-DA4D-425A-9A2A-39BDB8C9A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AFFF5D-57E2-4F7C-B152-246A1FC8B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BEEA-BB3C-481D-8B75-3348E1D78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697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ECA83-1C57-412A-9335-2531A5B1B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F0B3D3-321C-4400-B482-DA9D5444B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8BE2F8-D0E9-4E73-8639-9F3AC0C82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92153D-885F-4F34-87BC-8902D373A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3600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BAB4DA-46EC-449B-9A3E-3483965D0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8CB2FF-6FAB-4BD8-9778-90A35405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F2175A-8D64-41EB-A603-C2DE43B96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85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6DC62F-EEA7-4AE1-ADEC-514F834AE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AC1850-E3F4-4B24-B6FB-5BC6D8438C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A075F3-45D1-4EE3-8C62-04AEEAD06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B007A1-36C1-4F2F-998F-BED766621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81634B-B2E0-462C-872B-DBB82D684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6C2D1F-5C40-4C0D-ACF1-07E2EDF09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978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1FF12D-0E9D-48DE-8434-29AA4C8663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ACCA7A9-C2EB-41E5-94B0-F30DCBFEDB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B4423E-42ED-4093-BF8D-0F22EF246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AF915E-BE6A-47B6-98A3-C7877BC3A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23D99-EC4B-4AC2-A579-21D7854E1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AB81E3-086C-4EE4-85AD-E87B9DD3F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7396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7C2E48-BD78-42DE-AA42-B6555CAA2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8D469D-8E15-4D70-871E-AB968FC0E0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66E4A4-06D7-4F93-8C93-ACA28E963C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4851A-2893-4F80-8F02-E58CF51D49B1}" type="datetimeFigureOut">
              <a:rPr lang="en-GB" smtClean="0"/>
              <a:t>29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CF452C-00F7-4F72-8B74-DE51A2D0DE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A55A02-4D0C-451F-A91E-15F6A523F2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43342-4BC3-4043-9059-C4DE59CDCA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282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CE7CEC4-1E98-40BF-A0EC-17B6113A7277}"/>
              </a:ext>
            </a:extLst>
          </p:cNvPr>
          <p:cNvSpPr txBox="1"/>
          <p:nvPr/>
        </p:nvSpPr>
        <p:spPr>
          <a:xfrm>
            <a:off x="63125" y="807456"/>
            <a:ext cx="1880739" cy="3770263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 dirty="0">
                <a:solidFill>
                  <a:schemeClr val="tx1"/>
                </a:solidFill>
                <a:effectLst/>
                <a:latin typeface="Arial"/>
                <a:cs typeface="Arial"/>
              </a:rPr>
              <a:t>Known Risk Factors for Higher Grief Support Needs</a:t>
            </a:r>
          </a:p>
          <a:p>
            <a:pPr algn="ctr"/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SITUATIONAL FACTOR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Financial hardship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Social Isolation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Relationship</a:t>
            </a:r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 with health providers</a:t>
            </a:r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 around the loss</a:t>
            </a:r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LOSS FACTOR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Unexpected death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Death of a child 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Loss of support system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Unable to say goodbye / unfinished business</a:t>
            </a:r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INDIVIDUAL FACTOR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Complex relationship with the deceased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Multiple losse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History of psychological difficulti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E3B1DCB-D153-4F9A-9FC3-47F7EF9BB90D}"/>
              </a:ext>
            </a:extLst>
          </p:cNvPr>
          <p:cNvSpPr txBox="1"/>
          <p:nvPr/>
        </p:nvSpPr>
        <p:spPr>
          <a:xfrm>
            <a:off x="2189842" y="809474"/>
            <a:ext cx="2156274" cy="5155257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 dirty="0">
                <a:solidFill>
                  <a:schemeClr val="tx1"/>
                </a:solidFill>
                <a:effectLst/>
                <a:latin typeface="Arial"/>
                <a:cs typeface="Arial"/>
              </a:rPr>
              <a:t>Known Indicators of Higher Grief Support Needs</a:t>
            </a:r>
          </a:p>
          <a:p>
            <a:pPr algn="ctr"/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cap="all" dirty="0">
                <a:solidFill>
                  <a:schemeClr val="tx1"/>
                </a:solidFill>
                <a:effectLst/>
                <a:latin typeface="Arial"/>
                <a:cs typeface="Arial"/>
              </a:rPr>
              <a:t>Overwhelming emotion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Sadness, anger, anxiety, regret guilt, shame</a:t>
            </a: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cap="all" dirty="0">
                <a:solidFill>
                  <a:schemeClr val="tx1"/>
                </a:solidFill>
                <a:effectLst/>
                <a:latin typeface="Arial"/>
                <a:cs typeface="Arial"/>
              </a:rPr>
              <a:t>Loss of meaning &amp; purpose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Identity disruption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Frozen: What do I do now?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Spiritual Crisis</a:t>
            </a: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cap="all" dirty="0">
                <a:solidFill>
                  <a:schemeClr val="tx1"/>
                </a:solidFill>
                <a:effectLst/>
                <a:latin typeface="Arial"/>
                <a:cs typeface="Arial"/>
              </a:rPr>
              <a:t>Burden of expectations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From self</a:t>
            </a:r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 and others</a:t>
            </a:r>
          </a:p>
          <a:p>
            <a:endParaRPr lang="en-GB" sz="1000" u="sng" dirty="0">
              <a:solidFill>
                <a:schemeClr val="tx1"/>
              </a:solidFill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latin typeface="Arial"/>
                <a:cs typeface="Arial"/>
              </a:rPr>
              <a:t>SELF CRITICISM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About the death or about grieving</a:t>
            </a: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TRAUMATIC MEMORIES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Of how the deceased died or memories involving the deceased</a:t>
            </a: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AVOIDANCE</a:t>
            </a:r>
          </a:p>
          <a:p>
            <a:r>
              <a:rPr lang="en-GB" sz="1000" dirty="0">
                <a:solidFill>
                  <a:schemeClr val="tx1"/>
                </a:solidFill>
                <a:latin typeface="Arial"/>
                <a:cs typeface="Arial"/>
              </a:rPr>
              <a:t>Of emotion, memories, sensations, thoughts</a:t>
            </a:r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endParaRPr lang="en-GB" sz="1000" dirty="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PHYSICALITY OF GRIEF</a:t>
            </a:r>
          </a:p>
          <a:p>
            <a:r>
              <a:rPr lang="en-GB" sz="1000" dirty="0">
                <a:solidFill>
                  <a:schemeClr val="tx1"/>
                </a:solidFill>
                <a:effectLst/>
                <a:latin typeface="Arial"/>
                <a:cs typeface="Arial"/>
              </a:rPr>
              <a:t>Concentration, sleep, pain, fatigue</a:t>
            </a:r>
          </a:p>
          <a:p>
            <a:endParaRPr lang="en-GB" sz="1000" dirty="0">
              <a:solidFill>
                <a:schemeClr val="tx1"/>
              </a:solidFill>
              <a:latin typeface="Arial"/>
              <a:cs typeface="Arial"/>
            </a:endParaRPr>
          </a:p>
          <a:p>
            <a:r>
              <a:rPr lang="en-GB" sz="1000" u="sng" dirty="0">
                <a:solidFill>
                  <a:schemeClr val="tx1"/>
                </a:solidFill>
                <a:effectLst/>
                <a:latin typeface="Arial"/>
                <a:cs typeface="Arial"/>
              </a:rPr>
              <a:t>ISOLATION &amp; LONELINESS</a:t>
            </a:r>
          </a:p>
          <a:p>
            <a:endParaRPr lang="en-GB" sz="1000" u="sng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841C77-729E-41B1-A9EF-A7F10450A9E8}"/>
              </a:ext>
            </a:extLst>
          </p:cNvPr>
          <p:cNvSpPr txBox="1"/>
          <p:nvPr/>
        </p:nvSpPr>
        <p:spPr>
          <a:xfrm>
            <a:off x="4592094" y="1711192"/>
            <a:ext cx="2282340" cy="3524042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>
                <a:solidFill>
                  <a:schemeClr val="tx1"/>
                </a:solidFill>
                <a:effectLst/>
                <a:latin typeface="Arial"/>
                <a:cs typeface="Arial"/>
              </a:rPr>
              <a:t>Intervention Components</a:t>
            </a:r>
          </a:p>
          <a:p>
            <a:pPr algn="ctr"/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REAL STORIES</a:t>
            </a:r>
          </a:p>
          <a:p>
            <a:r>
              <a:rPr lang="en-GB" sz="1000">
                <a:solidFill>
                  <a:srgbClr val="333333"/>
                </a:solidFill>
                <a:latin typeface="Arial"/>
                <a:cs typeface="Arial"/>
              </a:rPr>
              <a:t>Normalising a range of grief responses, highlighting indicators of higher grief support needs and how people respond</a:t>
            </a:r>
            <a:endParaRPr lang="en-GB" sz="1000">
              <a:latin typeface="Arial"/>
              <a:cs typeface="Arial"/>
            </a:endParaRPr>
          </a:p>
          <a:p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SKILLS TRAINING</a:t>
            </a:r>
            <a:r>
              <a:rPr lang="en-GB" sz="1000" u="sng">
                <a:solidFill>
                  <a:schemeClr val="tx1"/>
                </a:solidFill>
                <a:latin typeface="Arial"/>
                <a:cs typeface="Arial"/>
              </a:rPr>
              <a:t>: OPEN, AWARE &amp; ENGAGED</a:t>
            </a:r>
            <a:endParaRPr lang="en-GB" sz="1000" u="sng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Videos, audio exercises, imagery, metaphors, worksheets</a:t>
            </a:r>
          </a:p>
          <a:p>
            <a:endParaRPr lang="en-GB" sz="1000">
              <a:solidFill>
                <a:schemeClr val="tx1"/>
              </a:solidFill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ENGAGING &amp; SOOTHING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Colour palette, nature imagery, poetry, flexibility of choices, relationship with site</a:t>
            </a:r>
          </a:p>
          <a:p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INTEGRATION OF OTHER APPROACHES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Self compassion, continuing bonds, dual process, educ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02B48D-B40A-4DEB-9884-6A9354E4C575}"/>
              </a:ext>
            </a:extLst>
          </p:cNvPr>
          <p:cNvSpPr txBox="1"/>
          <p:nvPr/>
        </p:nvSpPr>
        <p:spPr>
          <a:xfrm>
            <a:off x="4583100" y="564039"/>
            <a:ext cx="2288726" cy="90794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>
                <a:solidFill>
                  <a:schemeClr val="tx1"/>
                </a:solidFill>
                <a:effectLst/>
                <a:latin typeface="Arial"/>
                <a:cs typeface="Arial"/>
              </a:rPr>
              <a:t>Contextual Considerations</a:t>
            </a:r>
          </a:p>
          <a:p>
            <a:pPr algn="ctr"/>
            <a:endParaRPr lang="en-GB" sz="1000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 FACTORS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ternet access, </a:t>
            </a:r>
            <a:r>
              <a:rPr lang="en-GB" sz="1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iliarity</a:t>
            </a:r>
            <a:r>
              <a:rPr lang="en-GB" sz="100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100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vigation, </a:t>
            </a:r>
            <a:r>
              <a:rPr lang="en-GB" sz="1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essibility </a:t>
            </a:r>
            <a:endParaRPr lang="en-GB" sz="1000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CAF981-5978-4CA9-9D78-C2E60BA8B581}"/>
              </a:ext>
            </a:extLst>
          </p:cNvPr>
          <p:cNvSpPr txBox="1"/>
          <p:nvPr/>
        </p:nvSpPr>
        <p:spPr>
          <a:xfrm>
            <a:off x="9636793" y="475246"/>
            <a:ext cx="2416713" cy="3046988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>
                <a:solidFill>
                  <a:schemeClr val="tx1"/>
                </a:solidFill>
                <a:effectLst/>
                <a:latin typeface="Arial"/>
                <a:cs typeface="Arial"/>
              </a:rPr>
              <a:t>Outcomes</a:t>
            </a:r>
          </a:p>
          <a:p>
            <a:pPr algn="ctr"/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INDIVIDUAL SHORT TERM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motion tolerance and regulation, active coping, seeking social support. Increased wellbeing, increased psychological flexibility</a:t>
            </a:r>
          </a:p>
          <a:p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INDIVIDUAL LONG TERM</a:t>
            </a:r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ngaging in things that matter, reconnecting with relationships, making new relationships, Improvements in self care</a:t>
            </a:r>
          </a:p>
          <a:p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latin typeface="Arial"/>
                <a:cs typeface="Arial"/>
              </a:rPr>
              <a:t>BEREAVEMENT SUPPORT VOLUNTEERS</a:t>
            </a:r>
            <a:endParaRPr lang="en-GB" sz="1000" u="sng" strike="sngStrike">
              <a:solidFill>
                <a:schemeClr val="tx1"/>
              </a:solidFill>
              <a:latin typeface="Arial"/>
              <a:cs typeface="Arial"/>
            </a:endParaRP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nhanced skills and tools</a:t>
            </a:r>
          </a:p>
          <a:p>
            <a:r>
              <a:rPr lang="en-GB" sz="1000">
                <a:solidFill>
                  <a:schemeClr val="tx1"/>
                </a:solidFill>
                <a:latin typeface="Arial"/>
                <a:cs typeface="Arial"/>
              </a:rPr>
              <a:t>Increased psychological flexibility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Greater confide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45E6ED-6FCA-4873-A685-6CB7760D043A}"/>
              </a:ext>
            </a:extLst>
          </p:cNvPr>
          <p:cNvSpPr txBox="1"/>
          <p:nvPr/>
        </p:nvSpPr>
        <p:spPr>
          <a:xfrm>
            <a:off x="7106966" y="1025874"/>
            <a:ext cx="2303652" cy="4739759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sz="1300">
                <a:solidFill>
                  <a:schemeClr val="tx1"/>
                </a:solidFill>
                <a:effectLst/>
                <a:latin typeface="Arial"/>
                <a:cs typeface="Arial"/>
              </a:rPr>
              <a:t>Change Mechanisms</a:t>
            </a:r>
          </a:p>
          <a:p>
            <a:pPr algn="ctr"/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NORMALISATION</a:t>
            </a:r>
          </a:p>
          <a:p>
            <a:endParaRPr lang="en-GB" sz="1000" u="sng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PROVIDING HOPE</a:t>
            </a:r>
          </a:p>
          <a:p>
            <a:endParaRPr lang="en-GB" sz="1000" u="sng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MEANING MAKING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Perspective taking, value / pain connection, unhooking from unhelpful stories</a:t>
            </a:r>
          </a:p>
          <a:p>
            <a:endParaRPr lang="en-GB" sz="1000" u="sng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EMOTION REGULATION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xpression, comforting, soothing, distress tolerance</a:t>
            </a:r>
          </a:p>
          <a:p>
            <a:endParaRPr lang="en-GB" sz="1000">
              <a:solidFill>
                <a:schemeClr val="tx1"/>
              </a:solidFill>
              <a:effectLst/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INCREASED PSYCHOLOGICAL FLEXIBILITY 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nhanced </a:t>
            </a:r>
            <a:r>
              <a:rPr lang="en-GB" sz="1000" b="1">
                <a:solidFill>
                  <a:schemeClr val="tx1"/>
                </a:solidFill>
                <a:effectLst/>
                <a:latin typeface="Arial"/>
                <a:cs typeface="Arial"/>
              </a:rPr>
              <a:t>openness </a:t>
            </a:r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to emotions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Stepping back from thinking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Enhanced </a:t>
            </a:r>
            <a:r>
              <a:rPr lang="en-GB" sz="1000" b="1">
                <a:solidFill>
                  <a:schemeClr val="tx1"/>
                </a:solidFill>
                <a:effectLst/>
                <a:latin typeface="Arial"/>
                <a:cs typeface="Arial"/>
              </a:rPr>
              <a:t>awareness</a:t>
            </a:r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  of influences and consequences of responses</a:t>
            </a:r>
          </a:p>
          <a:p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Connection with what matters now</a:t>
            </a:r>
          </a:p>
          <a:p>
            <a:r>
              <a:rPr lang="en-GB" sz="1000" b="1">
                <a:solidFill>
                  <a:schemeClr val="tx1"/>
                </a:solidFill>
                <a:latin typeface="Arial"/>
                <a:cs typeface="Arial"/>
              </a:rPr>
              <a:t>Engaging</a:t>
            </a:r>
            <a:r>
              <a:rPr lang="en-GB" sz="1000">
                <a:solidFill>
                  <a:schemeClr val="tx1"/>
                </a:solidFill>
                <a:latin typeface="Arial"/>
                <a:cs typeface="Arial"/>
              </a:rPr>
              <a:t> in</a:t>
            </a:r>
            <a:r>
              <a:rPr lang="en-GB" sz="1000">
                <a:solidFill>
                  <a:schemeClr val="tx1"/>
                </a:solidFill>
                <a:effectLst/>
                <a:latin typeface="Arial"/>
                <a:cs typeface="Arial"/>
              </a:rPr>
              <a:t> concrete actions to live well with grief.</a:t>
            </a:r>
          </a:p>
          <a:p>
            <a:endParaRPr lang="en-GB" sz="1000">
              <a:solidFill>
                <a:schemeClr val="tx1"/>
              </a:solidFill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latin typeface="Arial"/>
                <a:cs typeface="Arial"/>
              </a:rPr>
              <a:t>SOCIAL SUPPORT</a:t>
            </a:r>
          </a:p>
          <a:p>
            <a:r>
              <a:rPr lang="en-GB" sz="1000">
                <a:solidFill>
                  <a:schemeClr val="tx1"/>
                </a:solidFill>
                <a:latin typeface="Arial"/>
                <a:cs typeface="Arial"/>
              </a:rPr>
              <a:t>Support from volunteer listener</a:t>
            </a:r>
          </a:p>
          <a:p>
            <a:r>
              <a:rPr lang="en-GB" sz="1000">
                <a:solidFill>
                  <a:schemeClr val="tx1"/>
                </a:solidFill>
                <a:latin typeface="Arial"/>
                <a:cs typeface="Arial"/>
              </a:rPr>
              <a:t>Opening up to friends and family</a:t>
            </a:r>
          </a:p>
          <a:p>
            <a:r>
              <a:rPr lang="en-GB" sz="1000">
                <a:solidFill>
                  <a:schemeClr val="tx1"/>
                </a:solidFill>
                <a:latin typeface="Arial"/>
                <a:cs typeface="Arial"/>
              </a:rPr>
              <a:t>Feel part of a grief commun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CCF7A2E-2CBA-46C1-8809-9B57B8771257}"/>
              </a:ext>
            </a:extLst>
          </p:cNvPr>
          <p:cNvSpPr txBox="1"/>
          <p:nvPr/>
        </p:nvSpPr>
        <p:spPr>
          <a:xfrm>
            <a:off x="4592065" y="5530500"/>
            <a:ext cx="2288726" cy="9079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GB" sz="1300">
                <a:effectLst/>
                <a:latin typeface="Arial"/>
                <a:cs typeface="Arial"/>
              </a:rPr>
              <a:t>Volunteer Support</a:t>
            </a:r>
          </a:p>
          <a:p>
            <a:endParaRPr lang="en-GB" sz="1000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00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lationship, emotional expression, active listening, ACT skills delivery and reinforcement, trouble shooti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0FBBBC9-C903-49DF-B548-22CC4690E969}"/>
              </a:ext>
            </a:extLst>
          </p:cNvPr>
          <p:cNvSpPr txBox="1"/>
          <p:nvPr/>
        </p:nvSpPr>
        <p:spPr>
          <a:xfrm>
            <a:off x="9649871" y="3953905"/>
            <a:ext cx="2421300" cy="2585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91440" tIns="45720" rIns="91440" bIns="45720" anchor="t">
            <a:spAutoFit/>
          </a:bodyPr>
          <a:lstStyle/>
          <a:p>
            <a:pPr algn="ctr"/>
            <a:r>
              <a:rPr lang="en-GB" sz="1300">
                <a:effectLst/>
                <a:latin typeface="Arial"/>
                <a:cs typeface="Arial"/>
              </a:rPr>
              <a:t>Impact</a:t>
            </a:r>
          </a:p>
          <a:p>
            <a:r>
              <a:rPr lang="en-GB" sz="1000" u="sng">
                <a:latin typeface="Arial"/>
                <a:cs typeface="Arial"/>
              </a:rPr>
              <a:t>INDIVIDUAL</a:t>
            </a:r>
          </a:p>
          <a:p>
            <a:r>
              <a:rPr lang="en-GB" sz="1000">
                <a:solidFill>
                  <a:srgbClr val="333333"/>
                </a:solidFill>
                <a:latin typeface="Arial"/>
                <a:cs typeface="Arial"/>
              </a:rPr>
              <a:t>Everyone who would benefit from </a:t>
            </a:r>
            <a:r>
              <a:rPr lang="en-GB" sz="1000">
                <a:solidFill>
                  <a:srgbClr val="333333"/>
                </a:solidFill>
                <a:effectLst/>
                <a:latin typeface="Arial"/>
                <a:cs typeface="Arial"/>
              </a:rPr>
              <a:t>bereavement</a:t>
            </a:r>
            <a:r>
              <a:rPr lang="en-GB" sz="1000">
                <a:solidFill>
                  <a:srgbClr val="333333"/>
                </a:solidFill>
                <a:latin typeface="Arial"/>
                <a:cs typeface="Arial"/>
              </a:rPr>
              <a:t> support will have immediate access to evidence based advice and support. </a:t>
            </a:r>
            <a:endParaRPr lang="en-GB" sz="1000">
              <a:latin typeface="Arial"/>
              <a:cs typeface="Arial"/>
            </a:endParaRPr>
          </a:p>
          <a:p>
            <a:endParaRPr lang="en-GB" sz="1000">
              <a:latin typeface="Arial"/>
              <a:cs typeface="Arial"/>
            </a:endParaRPr>
          </a:p>
          <a:p>
            <a:r>
              <a:rPr lang="en-GB" sz="1000" u="sng">
                <a:solidFill>
                  <a:schemeClr val="tx1"/>
                </a:solidFill>
                <a:effectLst/>
                <a:latin typeface="Arial"/>
                <a:cs typeface="Arial"/>
              </a:rPr>
              <a:t>ORGANISATIONAL</a:t>
            </a:r>
          </a:p>
          <a:p>
            <a:r>
              <a:rPr lang="en-GB" sz="1000">
                <a:effectLst/>
                <a:latin typeface="Arial"/>
                <a:cs typeface="Arial"/>
              </a:rPr>
              <a:t>Greater reach, serving more people, safe, effective and cost effective</a:t>
            </a:r>
            <a:r>
              <a:rPr lang="en-GB" sz="1000">
                <a:latin typeface="Arial"/>
                <a:cs typeface="Arial"/>
              </a:rPr>
              <a:t>, additional service offering</a:t>
            </a:r>
          </a:p>
          <a:p>
            <a:endParaRPr lang="en-GB" sz="1000">
              <a:latin typeface="Arial"/>
              <a:cs typeface="Arial"/>
            </a:endParaRPr>
          </a:p>
          <a:p>
            <a:r>
              <a:rPr lang="en-GB" sz="1000" u="sng">
                <a:latin typeface="Arial"/>
                <a:cs typeface="Arial"/>
              </a:rPr>
              <a:t>SOCIETAL</a:t>
            </a:r>
            <a:endParaRPr lang="en-GB" sz="1000">
              <a:latin typeface="Arial"/>
              <a:cs typeface="Arial"/>
            </a:endParaRPr>
          </a:p>
          <a:p>
            <a:r>
              <a:rPr lang="en-GB" sz="1000">
                <a:latin typeface="Arial"/>
                <a:cs typeface="Arial"/>
              </a:rPr>
              <a:t>Grief support needs become recognised and validated, greater openness and awareness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0B418E62-BAF9-4898-9151-7385815CDE75}"/>
              </a:ext>
            </a:extLst>
          </p:cNvPr>
          <p:cNvSpPr/>
          <p:nvPr/>
        </p:nvSpPr>
        <p:spPr>
          <a:xfrm>
            <a:off x="1977081" y="3282718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28833537-5F22-40D7-9FE3-4B29DE6442F4}"/>
              </a:ext>
            </a:extLst>
          </p:cNvPr>
          <p:cNvSpPr/>
          <p:nvPr/>
        </p:nvSpPr>
        <p:spPr>
          <a:xfrm>
            <a:off x="4379299" y="3279774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02E02E5D-EF5F-40F8-9CBB-DE24C8E3BC6C}"/>
              </a:ext>
            </a:extLst>
          </p:cNvPr>
          <p:cNvSpPr/>
          <p:nvPr/>
        </p:nvSpPr>
        <p:spPr>
          <a:xfrm rot="5400000">
            <a:off x="5570494" y="1525208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5B8AE949-2D46-408F-BAE7-145D0C2C74B2}"/>
              </a:ext>
            </a:extLst>
          </p:cNvPr>
          <p:cNvSpPr/>
          <p:nvPr/>
        </p:nvSpPr>
        <p:spPr>
          <a:xfrm rot="5400000" flipH="1" flipV="1">
            <a:off x="5577156" y="5259301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56AFE298-7263-4267-8FCE-E04DDCFB4B8A}"/>
              </a:ext>
            </a:extLst>
          </p:cNvPr>
          <p:cNvSpPr/>
          <p:nvPr/>
        </p:nvSpPr>
        <p:spPr>
          <a:xfrm>
            <a:off x="6921295" y="2642685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Arrow: Bent-Up 2">
            <a:extLst>
              <a:ext uri="{FF2B5EF4-FFF2-40B4-BE49-F238E27FC236}">
                <a16:creationId xmlns:a16="http://schemas.microsoft.com/office/drawing/2014/main" id="{216BA74A-7934-411E-9D0F-F3BFB6241FF2}"/>
              </a:ext>
            </a:extLst>
          </p:cNvPr>
          <p:cNvSpPr/>
          <p:nvPr/>
        </p:nvSpPr>
        <p:spPr>
          <a:xfrm>
            <a:off x="7004261" y="5832126"/>
            <a:ext cx="308346" cy="308177"/>
          </a:xfrm>
          <a:prstGeom prst="bentUp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673349EE-7FB4-401B-9EAA-20F4ECBA5D16}"/>
              </a:ext>
            </a:extLst>
          </p:cNvPr>
          <p:cNvSpPr/>
          <p:nvPr/>
        </p:nvSpPr>
        <p:spPr>
          <a:xfrm>
            <a:off x="9440738" y="1998740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28484BAA-D295-41E7-9C28-5BD903B88D3E}"/>
              </a:ext>
            </a:extLst>
          </p:cNvPr>
          <p:cNvSpPr/>
          <p:nvPr/>
        </p:nvSpPr>
        <p:spPr>
          <a:xfrm rot="5400000">
            <a:off x="10781156" y="3664928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44FC73EF-C3B5-5776-BDA4-FCEA612AC960}"/>
              </a:ext>
            </a:extLst>
          </p:cNvPr>
          <p:cNvSpPr/>
          <p:nvPr/>
        </p:nvSpPr>
        <p:spPr>
          <a:xfrm flipH="1">
            <a:off x="6921294" y="3954482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Arrow: U-Turn 19">
            <a:extLst>
              <a:ext uri="{FF2B5EF4-FFF2-40B4-BE49-F238E27FC236}">
                <a16:creationId xmlns:a16="http://schemas.microsoft.com/office/drawing/2014/main" id="{6C7DC03E-7FAA-4DFF-8406-988B6E004DBC}"/>
              </a:ext>
            </a:extLst>
          </p:cNvPr>
          <p:cNvSpPr/>
          <p:nvPr/>
        </p:nvSpPr>
        <p:spPr>
          <a:xfrm>
            <a:off x="3268950" y="319159"/>
            <a:ext cx="4985359" cy="490315"/>
          </a:xfrm>
          <a:prstGeom prst="uturnArrow">
            <a:avLst>
              <a:gd name="adj1" fmla="val 23286"/>
              <a:gd name="adj2" fmla="val 25000"/>
              <a:gd name="adj3" fmla="val 29244"/>
              <a:gd name="adj4" fmla="val 0"/>
              <a:gd name="adj5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1" name="Arrow: U-Turn 20">
            <a:extLst>
              <a:ext uri="{FF2B5EF4-FFF2-40B4-BE49-F238E27FC236}">
                <a16:creationId xmlns:a16="http://schemas.microsoft.com/office/drawing/2014/main" id="{81E26FB1-19D9-4AC5-9872-BA4972E1FCB5}"/>
              </a:ext>
            </a:extLst>
          </p:cNvPr>
          <p:cNvSpPr/>
          <p:nvPr/>
        </p:nvSpPr>
        <p:spPr>
          <a:xfrm flipH="1" flipV="1">
            <a:off x="3240585" y="5994607"/>
            <a:ext cx="4941514" cy="739100"/>
          </a:xfrm>
          <a:prstGeom prst="uturnArrow">
            <a:avLst>
              <a:gd name="adj1" fmla="val 13126"/>
              <a:gd name="adj2" fmla="val 11114"/>
              <a:gd name="adj3" fmla="val 16375"/>
              <a:gd name="adj4" fmla="val 0"/>
              <a:gd name="adj5" fmla="val 100000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8002E6D-16B8-4444-9684-0653FB4DE8C3}"/>
              </a:ext>
            </a:extLst>
          </p:cNvPr>
          <p:cNvSpPr txBox="1"/>
          <p:nvPr/>
        </p:nvSpPr>
        <p:spPr>
          <a:xfrm>
            <a:off x="231569" y="5332442"/>
            <a:ext cx="17077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ey:</a:t>
            </a: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       Informs</a:t>
            </a: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       Influences</a:t>
            </a: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Arrow: Right 21">
            <a:extLst>
              <a:ext uri="{FF2B5EF4-FFF2-40B4-BE49-F238E27FC236}">
                <a16:creationId xmlns:a16="http://schemas.microsoft.com/office/drawing/2014/main" id="{13DB85CB-459C-4B76-A8E0-10EF99339F97}"/>
              </a:ext>
            </a:extLst>
          </p:cNvPr>
          <p:cNvSpPr/>
          <p:nvPr/>
        </p:nvSpPr>
        <p:spPr>
          <a:xfrm>
            <a:off x="471505" y="6277812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2EF955AE-4C1C-4B34-8A8A-7D76C1FC70BB}"/>
              </a:ext>
            </a:extLst>
          </p:cNvPr>
          <p:cNvSpPr/>
          <p:nvPr/>
        </p:nvSpPr>
        <p:spPr>
          <a:xfrm>
            <a:off x="471505" y="5838188"/>
            <a:ext cx="165934" cy="146282"/>
          </a:xfrm>
          <a:prstGeom prst="rightArrow">
            <a:avLst>
              <a:gd name="adj1" fmla="val 50000"/>
              <a:gd name="adj2" fmla="val 4787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2D0A706-E5D5-4A31-BCA0-6A71604702E9}"/>
              </a:ext>
            </a:extLst>
          </p:cNvPr>
          <p:cNvSpPr/>
          <p:nvPr/>
        </p:nvSpPr>
        <p:spPr>
          <a:xfrm>
            <a:off x="0" y="1"/>
            <a:ext cx="12192000" cy="6858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621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F222764A853D847A6FA4F6E50429B7A" ma:contentTypeVersion="15" ma:contentTypeDescription="Create a new document." ma:contentTypeScope="" ma:versionID="1f7b712048d525ac49c30ba29a7415d8">
  <xsd:schema xmlns:xsd="http://www.w3.org/2001/XMLSchema" xmlns:xs="http://www.w3.org/2001/XMLSchema" xmlns:p="http://schemas.microsoft.com/office/2006/metadata/properties" xmlns:ns2="e4864b2d-e1af-4338-87b4-5a6e643cd025" xmlns:ns3="aec5951c-0f2a-498b-9baf-77d3bd0a1dc7" targetNamespace="http://schemas.microsoft.com/office/2006/metadata/properties" ma:root="true" ma:fieldsID="f1096aca62a59524f9b288e427327e77" ns2:_="" ns3:_="">
    <xsd:import namespace="e4864b2d-e1af-4338-87b4-5a6e643cd025"/>
    <xsd:import namespace="aec5951c-0f2a-498b-9baf-77d3bd0a1dc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864b2d-e1af-4338-87b4-5a6e643cd0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d54eff52-6b6d-4e5f-a3b0-187f185b1db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15" nillable="true" ma:displayName="Location" ma:indexed="true" ma:internalName="MediaServiceLocatio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c5951c-0f2a-498b-9baf-77d3bd0a1dc7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b1cddfcd-71e5-4179-8cc7-8209acaaa530}" ma:internalName="TaxCatchAll" ma:showField="CatchAllData" ma:web="aec5951c-0f2a-498b-9baf-77d3bd0a1dc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4864b2d-e1af-4338-87b4-5a6e643cd025">
      <Terms xmlns="http://schemas.microsoft.com/office/infopath/2007/PartnerControls"/>
    </lcf76f155ced4ddcb4097134ff3c332f>
    <TaxCatchAll xmlns="aec5951c-0f2a-498b-9baf-77d3bd0a1dc7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8ED53D8-246B-4411-8FF2-4DD799DF4D8D}">
  <ds:schemaRefs>
    <ds:schemaRef ds:uri="aec5951c-0f2a-498b-9baf-77d3bd0a1dc7"/>
    <ds:schemaRef ds:uri="e4864b2d-e1af-4338-87b4-5a6e643cd02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C4AB6B4F-6C69-49D4-85B3-D6ED2C948531}">
  <ds:schemaRefs>
    <ds:schemaRef ds:uri="http://schemas.openxmlformats.org/package/2006/metadata/core-properties"/>
    <ds:schemaRef ds:uri="http://purl.org/dc/dcmitype/"/>
    <ds:schemaRef ds:uri="aec5951c-0f2a-498b-9baf-77d3bd0a1dc7"/>
    <ds:schemaRef ds:uri="http://schemas.microsoft.com/office/2006/metadata/properties"/>
    <ds:schemaRef ds:uri="e4864b2d-e1af-4338-87b4-5a6e643cd025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www.w3.org/XML/1998/namespace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64778278-80AD-4930-8E79-50413CB3616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433</Words>
  <Application>Microsoft Office PowerPoint</Application>
  <PresentationFormat>Widescreen</PresentationFormat>
  <Paragraphs>1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Gillanders</dc:creator>
  <cp:lastModifiedBy>Anne Canny</cp:lastModifiedBy>
  <cp:revision>3</cp:revision>
  <cp:lastPrinted>2024-12-23T09:23:28Z</cp:lastPrinted>
  <dcterms:created xsi:type="dcterms:W3CDTF">2024-11-14T16:49:41Z</dcterms:created>
  <dcterms:modified xsi:type="dcterms:W3CDTF">2025-05-29T16:34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F222764A853D847A6FA4F6E50429B7A</vt:lpwstr>
  </property>
  <property fmtid="{D5CDD505-2E9C-101B-9397-08002B2CF9AE}" pid="3" name="MediaServiceImageTags">
    <vt:lpwstr/>
  </property>
</Properties>
</file>